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932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328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058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941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24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624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424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446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110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984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075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80407-50D2-4AD5-B49C-F07C8BABFDC0}" type="datetimeFigureOut">
              <a:rPr lang="en-US" smtClean="0"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517ED-377B-4B4D-BE13-647418C39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825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020CA-0593-4F0D-9F27-ABD4BA482AA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914400" y="68249"/>
            <a:ext cx="6400800" cy="6065222"/>
            <a:chOff x="533400" y="609600"/>
            <a:chExt cx="6400800" cy="6065222"/>
          </a:xfrm>
        </p:grpSpPr>
        <p:sp>
          <p:nvSpPr>
            <p:cNvPr id="7" name="Rectangle 2"/>
            <p:cNvSpPr>
              <a:spLocks noChangeArrowheads="1"/>
            </p:cNvSpPr>
            <p:nvPr/>
          </p:nvSpPr>
          <p:spPr bwMode="auto">
            <a:xfrm>
              <a:off x="533400" y="708139"/>
              <a:ext cx="2362200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tabLst>
                  <a:tab pos="1104900" algn="l"/>
                </a:tabLs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0" hangingPunct="0"/>
              <a:r>
                <a:rPr lang="en-US" altLang="en-US" sz="700" b="1" dirty="0">
                  <a:solidFill>
                    <a:prstClr val="black"/>
                  </a:solidFill>
                  <a:ea typeface="Times New Roman" pitchFamily="18" charset="0"/>
                </a:rPr>
                <a:t>Entry: 1742</a:t>
              </a:r>
              <a:endParaRPr lang="en-US" altLang="en-US" sz="600" b="1" dirty="0">
                <a:solidFill>
                  <a:prstClr val="black"/>
                </a:solidFill>
              </a:endParaRPr>
            </a:p>
            <a:p>
              <a:pPr eaLnBrk="0" hangingPunct="0"/>
              <a:r>
                <a:rPr lang="en-US" altLang="en-US" sz="700" b="1" dirty="0">
                  <a:solidFill>
                    <a:prstClr val="black"/>
                  </a:solidFill>
                  <a:ea typeface="Times New Roman" pitchFamily="18" charset="0"/>
                </a:rPr>
                <a:t>Sample: HM175</a:t>
              </a:r>
              <a:endParaRPr lang="en-US" altLang="en-US" sz="600" b="1" dirty="0">
                <a:solidFill>
                  <a:prstClr val="black"/>
                </a:solidFill>
              </a:endParaRPr>
            </a:p>
            <a:p>
              <a:pPr eaLnBrk="0" hangingPunct="0"/>
              <a:r>
                <a:rPr lang="en-US" altLang="en-US" sz="700" b="1" dirty="0">
                  <a:solidFill>
                    <a:prstClr val="black"/>
                  </a:solidFill>
                  <a:ea typeface="Times New Roman" pitchFamily="18" charset="0"/>
                </a:rPr>
                <a:t>Position 1: C/T (Passed) </a:t>
              </a:r>
              <a:r>
                <a:rPr lang="en-US" altLang="en-US" sz="1400" b="1" dirty="0">
                  <a:solidFill>
                    <a:prstClr val="black"/>
                  </a:solidFill>
                  <a:ea typeface="Times New Roman" pitchFamily="18" charset="0"/>
                </a:rPr>
                <a:t>*</a:t>
              </a:r>
              <a:endParaRPr lang="en-US" altLang="en-US" sz="1400" b="1" dirty="0">
                <a:solidFill>
                  <a:prstClr val="black"/>
                </a:solidFill>
              </a:endParaRPr>
            </a:p>
          </p:txBody>
        </p:sp>
        <p:pic>
          <p:nvPicPr>
            <p:cNvPr id="1025" name="Picture 1" descr="2df91178-5ed5-4951-b351-fcf249055a7b-G1"/>
            <p:cNvPicPr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3282" y="609600"/>
              <a:ext cx="4750918" cy="2895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1" descr="2df91178-5ed5-4951-b351-fcf249055a7b-G7"/>
            <p:cNvPicPr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3282" y="3581400"/>
              <a:ext cx="4750918" cy="2971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>
              <a:off x="533400" y="3810000"/>
              <a:ext cx="1305464" cy="4154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700" b="1" dirty="0">
                  <a:solidFill>
                    <a:prstClr val="black"/>
                  </a:solidFill>
                  <a:latin typeface="Arial" pitchFamily="34" charset="0"/>
                  <a:ea typeface="Times New Roman" pitchFamily="18" charset="0"/>
                  <a:cs typeface="Arial" pitchFamily="34" charset="0"/>
                </a:rPr>
                <a:t>Entry: 6836</a:t>
              </a:r>
              <a:endParaRPr lang="en-US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700" b="1" dirty="0">
                  <a:solidFill>
                    <a:prstClr val="black"/>
                  </a:solidFill>
                  <a:latin typeface="Arial" pitchFamily="34" charset="0"/>
                  <a:ea typeface="Times New Roman" pitchFamily="18" charset="0"/>
                  <a:cs typeface="Arial" pitchFamily="34" charset="0"/>
                </a:rPr>
                <a:t>Sample: HM175</a:t>
              </a:r>
              <a:endParaRPr lang="en-US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700" b="1" dirty="0">
                  <a:solidFill>
                    <a:prstClr val="black"/>
                  </a:solidFill>
                  <a:latin typeface="Arial" pitchFamily="34" charset="0"/>
                  <a:ea typeface="Times New Roman" pitchFamily="18" charset="0"/>
                  <a:cs typeface="Arial" pitchFamily="34" charset="0"/>
                </a:rPr>
                <a:t>Position 1: C/T (Passed)</a:t>
              </a:r>
              <a:endParaRPr lang="en-US" altLang="en-US" sz="6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 rot="16200000">
              <a:off x="1107213" y="1847478"/>
              <a:ext cx="18075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Light Unit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1107213" y="4764301"/>
              <a:ext cx="18075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Light Units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352800" y="6428601"/>
              <a:ext cx="3124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ase dispensation sequence for incorporation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472110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9BCBB6B-B73E-447C-B0EC-C2AA9D5CC5E5}"/>
              </a:ext>
            </a:extLst>
          </p:cNvPr>
          <p:cNvSpPr txBox="1"/>
          <p:nvPr/>
        </p:nvSpPr>
        <p:spPr>
          <a:xfrm>
            <a:off x="609600" y="685800"/>
            <a:ext cx="7315200" cy="17211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representative </a:t>
            </a:r>
            <a:r>
              <a:rPr lang="en-US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yrograms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the heterozygosity in the clinical stool samples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wo SNVs at nucleotide positions 1742 and 6836 </a:t>
            </a:r>
            <a:r>
              <a:rPr lang="en-US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by NGS were confirmed by pyrosequenc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able 1). The representativ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rogram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substitution G to A at nucleotide position 1742 (*shown as C to T, due to the antisense primer applied for this SNV), and C to T at nucleotide position 6836 compared to the reference sequence (NCBI accession number: M14707) are shown.  The pyrosequencing method is described under Material and Methods. E = addition of enzyme, S = addition of substrate.  </a:t>
            </a:r>
          </a:p>
        </p:txBody>
      </p:sp>
    </p:spTree>
    <p:extLst>
      <p:ext uri="{BB962C8B-B14F-4D97-AF65-F5344CB8AC3E}">
        <p14:creationId xmlns:p14="http://schemas.microsoft.com/office/powerpoint/2010/main" val="2985476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53</Words>
  <Application>Microsoft Office PowerPoint</Application>
  <PresentationFormat>On-screen Show (4:3)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F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, Zhihui *</dc:creator>
  <cp:lastModifiedBy>Yang, Zhihui</cp:lastModifiedBy>
  <cp:revision>6</cp:revision>
  <dcterms:created xsi:type="dcterms:W3CDTF">2018-06-19T19:50:59Z</dcterms:created>
  <dcterms:modified xsi:type="dcterms:W3CDTF">2018-09-10T19:29:31Z</dcterms:modified>
</cp:coreProperties>
</file>